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5" r:id="rId4"/>
  </p:sldMasterIdLst>
  <p:notesMasterIdLst>
    <p:notesMasterId r:id="rId6"/>
  </p:notesMasterIdLst>
  <p:sldIdLst>
    <p:sldId id="1077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B424D36-0AC0-4FB8-BC77-E3AE89BE92F2}">
          <p14:sldIdLst>
            <p14:sldId id="107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731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CB30F05-51DC-EE3B-E060-205856E62819}" name="Szonja" initials="S" userId="Szonja" providerId="None"/>
  <p188:author id="{0C87D80B-1055-D504-BA85-D97A5BECF357}" name="Bita Manzouri" initials="BM" userId="6588022334cb73a1" providerId="Windows Live"/>
  <p188:author id="{DD840B8F-4CEF-706B-D5D1-37CAF2188CD2}" name="Sharon Farwell" initials="SF" userId="S::sharon.farwell@eu.santen.com::21787891-5470-4bc6-a327-1a7ae73fdd5a" providerId="AD"/>
  <p188:author id="{A4EF43D0-A093-5B70-B1B8-48E971E7B3E2}" name="Nicola Kličková" initials="NK" userId="Nicola Kličková" providerId="None"/>
  <p188:author id="{961907DE-885C-3268-E3D3-F58401DB2BB6}" name="Kirsty Mearns" initials="KM" userId="da9ea7b4062dcaa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56535"/>
    <a:srgbClr val="FF8181"/>
    <a:srgbClr val="E4FDF6"/>
    <a:srgbClr val="E2D6EC"/>
    <a:srgbClr val="FDF8D7"/>
    <a:srgbClr val="7030A0"/>
    <a:srgbClr val="FCE7F6"/>
    <a:srgbClr val="FACFEE"/>
    <a:srgbClr val="CAFBED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97F0A7-9FC0-4565-954B-80428B1CC0A5}" v="5" dt="2025-09-12T08:50:44.78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30" autoAdjust="0"/>
    <p:restoredTop sz="95033" autoAdjust="0"/>
  </p:normalViewPr>
  <p:slideViewPr>
    <p:cSldViewPr snapToGrid="0" showGuides="1">
      <p:cViewPr varScale="1">
        <p:scale>
          <a:sx n="79" d="100"/>
          <a:sy n="79" d="100"/>
        </p:scale>
        <p:origin x="763" y="72"/>
      </p:cViewPr>
      <p:guideLst>
        <p:guide orient="horz" pos="2137"/>
        <p:guide pos="731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83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ola Kličková" userId="783a97d07d92abba" providerId="LiveId" clId="{F195D316-F034-4480-A0F7-3B650AA65290}"/>
    <pc:docChg chg="undo custSel modSld">
      <pc:chgData name="Nicola Kličková" userId="783a97d07d92abba" providerId="LiveId" clId="{F195D316-F034-4480-A0F7-3B650AA65290}" dt="2025-09-12T08:51:03.758" v="185" actId="1076"/>
      <pc:docMkLst>
        <pc:docMk/>
      </pc:docMkLst>
      <pc:sldChg chg="addSp delSp modSp mod">
        <pc:chgData name="Nicola Kličková" userId="783a97d07d92abba" providerId="LiveId" clId="{F195D316-F034-4480-A0F7-3B650AA65290}" dt="2025-09-12T08:51:03.758" v="185" actId="1076"/>
        <pc:sldMkLst>
          <pc:docMk/>
          <pc:sldMk cId="3496375644" sldId="1077"/>
        </pc:sldMkLst>
        <pc:graphicFrameChg chg="mod modGraphic">
          <ac:chgData name="Nicola Kličková" userId="783a97d07d92abba" providerId="LiveId" clId="{F195D316-F034-4480-A0F7-3B650AA65290}" dt="2025-09-12T08:51:03.758" v="185" actId="1076"/>
          <ac:graphicFrameMkLst>
            <pc:docMk/>
            <pc:sldMk cId="3496375644" sldId="1077"/>
            <ac:graphicFrameMk id="21" creationId="{23BDF675-8675-F476-C891-7D329E46DE71}"/>
          </ac:graphicFrameMkLst>
        </pc:graphicFrameChg>
        <pc:picChg chg="add mod">
          <ac:chgData name="Nicola Kličková" userId="783a97d07d92abba" providerId="LiveId" clId="{F195D316-F034-4480-A0F7-3B650AA65290}" dt="2025-09-12T08:51:03.758" v="185" actId="1076"/>
          <ac:picMkLst>
            <pc:docMk/>
            <pc:sldMk cId="3496375644" sldId="1077"/>
            <ac:picMk id="3" creationId="{40A08419-5AB1-1ABC-F022-59E80CF4C563}"/>
          </ac:picMkLst>
        </pc:picChg>
        <pc:picChg chg="add mod">
          <ac:chgData name="Nicola Kličková" userId="783a97d07d92abba" providerId="LiveId" clId="{F195D316-F034-4480-A0F7-3B650AA65290}" dt="2025-09-12T08:51:03.758" v="185" actId="1076"/>
          <ac:picMkLst>
            <pc:docMk/>
            <pc:sldMk cId="3496375644" sldId="1077"/>
            <ac:picMk id="5" creationId="{65E65F95-DE7F-3B9E-09D7-03B0E746953D}"/>
          </ac:picMkLst>
        </pc:picChg>
        <pc:picChg chg="add mod">
          <ac:chgData name="Nicola Kličková" userId="783a97d07d92abba" providerId="LiveId" clId="{F195D316-F034-4480-A0F7-3B650AA65290}" dt="2025-09-12T08:51:03.758" v="185" actId="1076"/>
          <ac:picMkLst>
            <pc:docMk/>
            <pc:sldMk cId="3496375644" sldId="1077"/>
            <ac:picMk id="7" creationId="{A5E3118E-9308-26E9-659A-9FAFC4657AE8}"/>
          </ac:picMkLst>
        </pc:picChg>
        <pc:picChg chg="add mod">
          <ac:chgData name="Nicola Kličková" userId="783a97d07d92abba" providerId="LiveId" clId="{F195D316-F034-4480-A0F7-3B650AA65290}" dt="2025-09-12T08:51:03.758" v="185" actId="1076"/>
          <ac:picMkLst>
            <pc:docMk/>
            <pc:sldMk cId="3496375644" sldId="1077"/>
            <ac:picMk id="9" creationId="{68720A14-03B2-875D-91B0-413684EF9AD0}"/>
          </ac:picMkLst>
        </pc:picChg>
        <pc:picChg chg="del">
          <ac:chgData name="Nicola Kličková" userId="783a97d07d92abba" providerId="LiveId" clId="{F195D316-F034-4480-A0F7-3B650AA65290}" dt="2025-09-12T08:47:27.320" v="38" actId="478"/>
          <ac:picMkLst>
            <pc:docMk/>
            <pc:sldMk cId="3496375644" sldId="1077"/>
            <ac:picMk id="23" creationId="{0334AC94-45E4-4F3A-A2C7-87C4D8396BBC}"/>
          </ac:picMkLst>
        </pc:picChg>
        <pc:picChg chg="del">
          <ac:chgData name="Nicola Kličková" userId="783a97d07d92abba" providerId="LiveId" clId="{F195D316-F034-4480-A0F7-3B650AA65290}" dt="2025-09-12T08:47:27.718" v="39" actId="478"/>
          <ac:picMkLst>
            <pc:docMk/>
            <pc:sldMk cId="3496375644" sldId="1077"/>
            <ac:picMk id="25" creationId="{F9AB74D2-844A-54D7-EC1D-6B02CE056C3D}"/>
          </ac:picMkLst>
        </pc:picChg>
        <pc:picChg chg="del mod">
          <ac:chgData name="Nicola Kličková" userId="783a97d07d92abba" providerId="LiveId" clId="{F195D316-F034-4480-A0F7-3B650AA65290}" dt="2025-09-12T08:47:12.344" v="30" actId="478"/>
          <ac:picMkLst>
            <pc:docMk/>
            <pc:sldMk cId="3496375644" sldId="1077"/>
            <ac:picMk id="27" creationId="{4B90EF35-A67D-6D70-9FCE-42AD0F8CE681}"/>
          </ac:picMkLst>
        </pc:picChg>
        <pc:picChg chg="del">
          <ac:chgData name="Nicola Kličková" userId="783a97d07d92abba" providerId="LiveId" clId="{F195D316-F034-4480-A0F7-3B650AA65290}" dt="2025-09-12T08:47:28.261" v="40" actId="478"/>
          <ac:picMkLst>
            <pc:docMk/>
            <pc:sldMk cId="3496375644" sldId="1077"/>
            <ac:picMk id="29" creationId="{CEDBFA8F-E623-997A-5F4E-AAC8488C692B}"/>
          </ac:picMkLst>
        </pc:picChg>
        <pc:picChg chg="del">
          <ac:chgData name="Nicola Kličková" userId="783a97d07d92abba" providerId="LiveId" clId="{F195D316-F034-4480-A0F7-3B650AA65290}" dt="2025-09-12T08:47:28.611" v="41" actId="478"/>
          <ac:picMkLst>
            <pc:docMk/>
            <pc:sldMk cId="3496375644" sldId="1077"/>
            <ac:picMk id="31" creationId="{E6CEF76D-AC38-8A6A-1ADE-60186DB2CE17}"/>
          </ac:picMkLst>
        </pc:picChg>
        <pc:picChg chg="del">
          <ac:chgData name="Nicola Kličková" userId="783a97d07d92abba" providerId="LiveId" clId="{F195D316-F034-4480-A0F7-3B650AA65290}" dt="2025-09-12T08:47:30.035" v="42" actId="478"/>
          <ac:picMkLst>
            <pc:docMk/>
            <pc:sldMk cId="3496375644" sldId="1077"/>
            <ac:picMk id="34" creationId="{3ED0A868-74C3-9682-8631-B199868F7F51}"/>
          </ac:picMkLst>
        </pc:picChg>
        <pc:picChg chg="del">
          <ac:chgData name="Nicola Kličková" userId="783a97d07d92abba" providerId="LiveId" clId="{F195D316-F034-4480-A0F7-3B650AA65290}" dt="2025-09-12T08:47:12.344" v="30" actId="478"/>
          <ac:picMkLst>
            <pc:docMk/>
            <pc:sldMk cId="3496375644" sldId="1077"/>
            <ac:picMk id="36" creationId="{449013E0-D513-B75F-D1EE-59F8A8DBBA3D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8487DE-3D79-2E4E-A84E-9EA61794F01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3399AB-DA06-7245-8494-73DFDE83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457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758952"/>
            <a:ext cx="100584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4455620"/>
            <a:ext cx="100584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ACB96-8358-44D6-AC3F-D83F9AABF7B1}" type="datetime1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943735" y="6459785"/>
            <a:ext cx="4822804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814858" y="6459785"/>
            <a:ext cx="1312025" cy="365125"/>
          </a:xfrm>
        </p:spPr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1223715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F22EF-5A56-4E69-8A82-F843598FA2C3}" type="datetime1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1601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4778"/>
            <a:ext cx="2628900" cy="57574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4778"/>
            <a:ext cx="7734300" cy="5757422"/>
          </a:xfrm>
        </p:spPr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F5463-708F-4EA8-89B2-5358E74211A7}" type="datetime1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569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92C9-174F-42F1-AFCD-26C683C59991}" type="datetime1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9979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758952"/>
            <a:ext cx="100584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453128"/>
            <a:ext cx="100584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CAA6F-8B97-41C6-A324-77EAAFDA087D}" type="datetime1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25341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79" y="1845734"/>
            <a:ext cx="493776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45735"/>
            <a:ext cx="493776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E2383-EBCF-4909-BB62-9909974B8D38}" type="datetime1">
              <a:rPr lang="en-GB" smtClean="0"/>
              <a:t>12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0457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2582334"/>
            <a:ext cx="4937760" cy="337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2582334"/>
            <a:ext cx="4937760" cy="337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F3B93-ABB2-46A8-9701-47BA549AC5BC}" type="datetime1">
              <a:rPr lang="en-GB" smtClean="0"/>
              <a:t>12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7664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2ADCD-F407-46CC-9A6F-02B50BA58352}" type="datetime1">
              <a:rPr lang="en-GB" smtClean="0"/>
              <a:t>12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142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EA047-4C3F-48B7-906E-0897D27C3576}" type="datetime1">
              <a:rPr lang="en-GB" smtClean="0"/>
              <a:t>12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0148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" y="0"/>
            <a:ext cx="4050791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94359"/>
            <a:ext cx="32004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00600" y="731520"/>
            <a:ext cx="6492240" cy="52578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926080"/>
            <a:ext cx="32004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2" y="6459785"/>
            <a:ext cx="2618510" cy="365125"/>
          </a:xfrm>
        </p:spPr>
        <p:txBody>
          <a:bodyPr/>
          <a:lstStyle>
            <a:lvl1pPr algn="l">
              <a:defRPr/>
            </a:lvl1pPr>
          </a:lstStyle>
          <a:p>
            <a:fld id="{3578ACBE-688E-4EE9-8021-DB3452EEA38C}" type="datetime1">
              <a:rPr lang="en-GB" smtClean="0"/>
              <a:t>12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7124077" y="6459785"/>
            <a:ext cx="4648200" cy="365125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chemeClr val="tx2"/>
                </a:solidFill>
              </a:defRPr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83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12188825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491507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5074920"/>
            <a:ext cx="10113264" cy="822960"/>
          </a:xfrm>
        </p:spPr>
        <p:txBody>
          <a:bodyPr lIns="91440" tIns="0" rIns="9144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" y="0"/>
            <a:ext cx="12191985" cy="4915076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80" y="5907023"/>
            <a:ext cx="10113264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5E3B6-828B-4D27-9EAC-A3CA333E71F7}" type="datetime1">
              <a:rPr lang="en-GB" smtClean="0"/>
              <a:t>12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515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6400800"/>
            <a:ext cx="12192000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0" y="6334316"/>
            <a:ext cx="12192001" cy="659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5734"/>
            <a:ext cx="10058400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0" y="6459785"/>
            <a:ext cx="24722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74D8E095-3898-4F05-9C2E-361AFBB2E254}" type="datetime1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943735" y="6459785"/>
            <a:ext cx="482280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cap="all" baseline="0">
                <a:solidFill>
                  <a:srgbClr val="FFFFFF"/>
                </a:solidFill>
              </a:defRPr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15204" y="6459785"/>
            <a:ext cx="1312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173784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3880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</p:sldLayoutIdLst>
  <p:hf sldNum="0" hd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3840" userDrawn="1">
          <p15:clr>
            <a:srgbClr val="F26B43"/>
          </p15:clr>
        </p15:guide>
        <p15:guide id="3" pos="7423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23BDF675-8675-F476-C891-7D329E46DE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2224124"/>
              </p:ext>
            </p:extLst>
          </p:nvPr>
        </p:nvGraphicFramePr>
        <p:xfrm>
          <a:off x="2015247" y="690483"/>
          <a:ext cx="8161506" cy="521375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080753">
                  <a:extLst>
                    <a:ext uri="{9D8B030D-6E8A-4147-A177-3AD203B41FA5}">
                      <a16:colId xmlns:a16="http://schemas.microsoft.com/office/drawing/2014/main" val="922140182"/>
                    </a:ext>
                  </a:extLst>
                </a:gridCol>
                <a:gridCol w="4080753">
                  <a:extLst>
                    <a:ext uri="{9D8B030D-6E8A-4147-A177-3AD203B41FA5}">
                      <a16:colId xmlns:a16="http://schemas.microsoft.com/office/drawing/2014/main" val="3057692208"/>
                    </a:ext>
                  </a:extLst>
                </a:gridCol>
              </a:tblGrid>
              <a:tr h="2271597">
                <a:tc>
                  <a:txBody>
                    <a:bodyPr/>
                    <a:lstStyle/>
                    <a:p>
                      <a:pPr algn="ctr"/>
                      <a:endParaRPr lang="en-GB" b="1" dirty="0"/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b="1" dirty="0"/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986905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/>
                      <a:r>
                        <a:rPr lang="en-GB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rse confluent diffuse S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rse diffuse S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3666409"/>
                  </a:ext>
                </a:extLst>
              </a:tr>
              <a:tr h="2271600">
                <a:tc>
                  <a:txBody>
                    <a:bodyPr/>
                    <a:lstStyle/>
                    <a:p>
                      <a:pPr algn="ctr"/>
                      <a:endParaRPr lang="en-GB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286752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/>
                      <a:r>
                        <a:rPr lang="en-GB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rior third SPK and filament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 third fine confluent S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60000"/>
                          <a:lumOff val="4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0848916"/>
                  </a:ext>
                </a:extLst>
              </a:tr>
            </a:tbl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40A08419-5AB1-1ABC-F022-59E80CF4C5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8274" y="719667"/>
            <a:ext cx="3391849" cy="222505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5E65F95-DE7F-3B9E-09D7-03B0E746953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5254" y="719667"/>
            <a:ext cx="3391463" cy="2224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5E3118E-9308-26E9-659A-9FAFC4657AE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8467" y="3321808"/>
            <a:ext cx="3391463" cy="2224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8720A14-03B2-875D-91B0-413684EF9AD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5254" y="3321808"/>
            <a:ext cx="3391463" cy="222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375644"/>
      </p:ext>
    </p:extLst>
  </p:cSld>
  <p:clrMapOvr>
    <a:masterClrMapping/>
  </p:clrMapOvr>
</p:sld>
</file>

<file path=ppt/theme/theme1.xml><?xml version="1.0" encoding="utf-8"?>
<a:theme xmlns:a="http://schemas.openxmlformats.org/drawingml/2006/main" name="Retrospect">
  <a:themeElements>
    <a:clrScheme name="Custom 2">
      <a:dk1>
        <a:srgbClr val="595959"/>
      </a:dk1>
      <a:lt1>
        <a:sysClr val="window" lastClr="FFFFFF"/>
      </a:lt1>
      <a:dk2>
        <a:srgbClr val="000000"/>
      </a:dk2>
      <a:lt2>
        <a:srgbClr val="DBEFF9"/>
      </a:lt2>
      <a:accent1>
        <a:srgbClr val="0F6FC6"/>
      </a:accent1>
      <a:accent2>
        <a:srgbClr val="009DD9"/>
      </a:accent2>
      <a:accent3>
        <a:srgbClr val="0BD0D9"/>
      </a:accent3>
      <a:accent4>
        <a:srgbClr val="10CF9B"/>
      </a:accent4>
      <a:accent5>
        <a:srgbClr val="7CCA62"/>
      </a:accent5>
      <a:accent6>
        <a:srgbClr val="DB19A8"/>
      </a:accent6>
      <a:hlink>
        <a:srgbClr val="DB19A8"/>
      </a:hlink>
      <a:folHlink>
        <a:srgbClr val="009DD9"/>
      </a:folHlink>
    </a:clrScheme>
    <a:fontScheme name="Retrospect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D5D30E0F3A5214BAC6A4AAF1970CED0" ma:contentTypeVersion="20" ma:contentTypeDescription="Create a new document." ma:contentTypeScope="" ma:versionID="dac10138648294dc2d54aef0bbffa2f1">
  <xsd:schema xmlns:xsd="http://www.w3.org/2001/XMLSchema" xmlns:xs="http://www.w3.org/2001/XMLSchema" xmlns:p="http://schemas.microsoft.com/office/2006/metadata/properties" xmlns:ns2="54a82318-df7d-4c2f-88b3-7b65c926a23a" xmlns:ns3="79c36476-307c-47a2-bfa0-3878fccd02f6" targetNamespace="http://schemas.microsoft.com/office/2006/metadata/properties" ma:root="true" ma:fieldsID="0c0fab99b402b18b587d2b9203fa7252" ns2:_="" ns3:_="">
    <xsd:import namespace="54a82318-df7d-4c2f-88b3-7b65c926a23a"/>
    <xsd:import namespace="79c36476-307c-47a2-bfa0-3878fccd02f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DateTaken" minOccurs="0"/>
                <xsd:element ref="ns2:MediaServiceLocation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extra" minOccurs="0"/>
                <xsd:element ref="ns2:DateandTim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a82318-df7d-4c2f-88b3-7b65c926a23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75f9dbe3-e583-4f4b-88e5-419e9d87dc3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extra" ma:index="26" nillable="true" ma:displayName="extra" ma:format="Dropdown" ma:internalName="extra">
      <xsd:simpleType>
        <xsd:restriction base="dms:Text">
          <xsd:maxLength value="255"/>
        </xsd:restriction>
      </xsd:simpleType>
    </xsd:element>
    <xsd:element name="DateandTime" ma:index="27" nillable="true" ma:displayName="Date and Time" ma:format="DateOnly" ma:internalName="DateandTime">
      <xsd:simpleType>
        <xsd:restriction base="dms:DateTim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9c36476-307c-47a2-bfa0-3878fccd02f6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dbfcc402-02e6-473d-95c2-a29df9139fae}" ma:internalName="TaxCatchAll" ma:showField="CatchAllData" ma:web="79c36476-307c-47a2-bfa0-3878fccd02f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4a82318-df7d-4c2f-88b3-7b65c926a23a">
      <Terms xmlns="http://schemas.microsoft.com/office/infopath/2007/PartnerControls"/>
    </lcf76f155ced4ddcb4097134ff3c332f>
    <extra xmlns="54a82318-df7d-4c2f-88b3-7b65c926a23a" xsi:nil="true"/>
    <TaxCatchAll xmlns="79c36476-307c-47a2-bfa0-3878fccd02f6" xsi:nil="true"/>
    <DateandTime xmlns="54a82318-df7d-4c2f-88b3-7b65c926a23a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924CC32-D9C4-48AE-85EF-855DE43A0E2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a82318-df7d-4c2f-88b3-7b65c926a23a"/>
    <ds:schemaRef ds:uri="79c36476-307c-47a2-bfa0-3878fccd02f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989D5E1-14E2-4FB8-830E-60D8E8F173AE}">
  <ds:schemaRefs>
    <ds:schemaRef ds:uri="http://purl.org/dc/elements/1.1/"/>
    <ds:schemaRef ds:uri="http://purl.org/dc/terms/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  <ds:schemaRef ds:uri="79c36476-307c-47a2-bfa0-3878fccd02f6"/>
    <ds:schemaRef ds:uri="54a82318-df7d-4c2f-88b3-7b65c926a23a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EA4AFE6A-81BE-4FCE-B143-C1995F36E66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17266</TotalTime>
  <Words>1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Retrospec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y Eye Disease: Assessment and management UK consensus 2025</dc:title>
  <dc:creator>Nicola Kličková</dc:creator>
  <cp:lastModifiedBy>Nicola Kličková</cp:lastModifiedBy>
  <cp:revision>33</cp:revision>
  <cp:lastPrinted>2025-03-18T10:48:09Z</cp:lastPrinted>
  <dcterms:created xsi:type="dcterms:W3CDTF">2024-12-11T08:33:10Z</dcterms:created>
  <dcterms:modified xsi:type="dcterms:W3CDTF">2025-09-12T08:5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D5D30E0F3A5214BAC6A4AAF1970CED0</vt:lpwstr>
  </property>
  <property fmtid="{D5CDD505-2E9C-101B-9397-08002B2CF9AE}" pid="3" name="MediaServiceImageTags">
    <vt:lpwstr/>
  </property>
</Properties>
</file>